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8229600" cy="9875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30" autoAdjust="0"/>
    <p:restoredTop sz="94660"/>
  </p:normalViewPr>
  <p:slideViewPr>
    <p:cSldViewPr snapToGrid="0">
      <p:cViewPr varScale="1">
        <p:scale>
          <a:sx n="88" d="100"/>
          <a:sy n="88" d="100"/>
        </p:scale>
        <p:origin x="17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1616255"/>
            <a:ext cx="6995160" cy="3438255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7102"/>
            <a:ext cx="6172200" cy="2384374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920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382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525797"/>
            <a:ext cx="1774508" cy="836931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525797"/>
            <a:ext cx="5220653" cy="836931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531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30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2462104"/>
            <a:ext cx="7098030" cy="4108074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6609042"/>
            <a:ext cx="7098030" cy="216033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048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2628985"/>
            <a:ext cx="3497580" cy="626612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2628985"/>
            <a:ext cx="3497580" cy="626612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732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525799"/>
            <a:ext cx="7098030" cy="19088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2420953"/>
            <a:ext cx="3481506" cy="1186471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3607424"/>
            <a:ext cx="3481506" cy="530597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2420953"/>
            <a:ext cx="3498652" cy="1186471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3607424"/>
            <a:ext cx="3498652" cy="530597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752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99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935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58389"/>
            <a:ext cx="2654260" cy="2304362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421940"/>
            <a:ext cx="4166235" cy="7018246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962752"/>
            <a:ext cx="2654260" cy="5488863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727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58389"/>
            <a:ext cx="2654260" cy="2304362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421940"/>
            <a:ext cx="4166235" cy="7018246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962752"/>
            <a:ext cx="2654260" cy="5488863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2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525799"/>
            <a:ext cx="7098030" cy="19088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2628985"/>
            <a:ext cx="7098030" cy="62661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9153441"/>
            <a:ext cx="1851660" cy="5257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9153441"/>
            <a:ext cx="2777490" cy="5257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9153441"/>
            <a:ext cx="1851660" cy="5257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032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0" y="382112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0" y="4576853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e)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905556" y="2472522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d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902210" y="4576853"/>
            <a:ext cx="406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f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-32797" y="7228028"/>
            <a:ext cx="439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g)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0" y="2477939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636232" y="-45893"/>
            <a:ext cx="77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nus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636232" y="6866812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ecies</a:t>
            </a: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570" y="676145"/>
            <a:ext cx="3959352" cy="1845327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4881" y="721630"/>
            <a:ext cx="3959352" cy="1869036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570" y="2787640"/>
            <a:ext cx="3959352" cy="1888793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31895" y="2835058"/>
            <a:ext cx="3959352" cy="1841375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816" y="4985498"/>
            <a:ext cx="3959352" cy="1845327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92859" y="4987473"/>
            <a:ext cx="3959352" cy="1841375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570" y="7633347"/>
            <a:ext cx="3959352" cy="1813871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92859" y="7633347"/>
            <a:ext cx="3959352" cy="1813871"/>
          </a:xfrm>
          <a:prstGeom prst="rect">
            <a:avLst/>
          </a:prstGeom>
        </p:spPr>
      </p:pic>
      <p:sp>
        <p:nvSpPr>
          <p:cNvPr id="65" name="TextBox 64"/>
          <p:cNvSpPr txBox="1"/>
          <p:nvPr/>
        </p:nvSpPr>
        <p:spPr>
          <a:xfrm>
            <a:off x="3984810" y="7228028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h)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1565498" y="7382296"/>
            <a:ext cx="1207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Unclassified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5255223" y="7382296"/>
            <a:ext cx="20783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 </a:t>
            </a:r>
            <a:r>
              <a:rPr lang="en-US" sz="1600" b="1" i="1" dirty="0" err="1"/>
              <a:t>luteciae</a:t>
            </a:r>
            <a:endParaRPr lang="en-US" sz="1600" b="1" i="1" dirty="0"/>
          </a:p>
        </p:txBody>
      </p:sp>
      <p:sp>
        <p:nvSpPr>
          <p:cNvPr id="68" name="TextBox 67"/>
          <p:cNvSpPr txBox="1"/>
          <p:nvPr/>
        </p:nvSpPr>
        <p:spPr>
          <a:xfrm>
            <a:off x="7340732" y="9489982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2.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779756" y="382112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603682" y="566778"/>
            <a:ext cx="1207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Unclassified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326670" y="566778"/>
            <a:ext cx="1289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Enterococcus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76083" y="2815515"/>
            <a:ext cx="12837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Lactobacillus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6403648" y="2815515"/>
            <a:ext cx="1358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420362" y="4966736"/>
            <a:ext cx="1390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Ruminococcus</a:t>
            </a:r>
            <a:endParaRPr lang="en-US" sz="1600" b="1" i="1" dirty="0"/>
          </a:p>
        </p:txBody>
      </p:sp>
      <p:sp>
        <p:nvSpPr>
          <p:cNvPr id="53" name="TextBox 52"/>
          <p:cNvSpPr txBox="1"/>
          <p:nvPr/>
        </p:nvSpPr>
        <p:spPr>
          <a:xfrm>
            <a:off x="5621688" y="4966736"/>
            <a:ext cx="9947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Klebsiella</a:t>
            </a:r>
            <a:endParaRPr lang="en-US" sz="1600" b="1" i="1" dirty="0"/>
          </a:p>
        </p:txBody>
      </p:sp>
    </p:spTree>
    <p:extLst>
      <p:ext uri="{BB962C8B-B14F-4D97-AF65-F5344CB8AC3E}">
        <p14:creationId xmlns:p14="http://schemas.microsoft.com/office/powerpoint/2010/main" val="4033629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4</TotalTime>
  <Words>39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glarz, Monika - ARS</dc:creator>
  <cp:lastModifiedBy>Weglarz, Monika - ARS</cp:lastModifiedBy>
  <cp:revision>24</cp:revision>
  <dcterms:created xsi:type="dcterms:W3CDTF">2020-11-23T13:57:10Z</dcterms:created>
  <dcterms:modified xsi:type="dcterms:W3CDTF">2022-05-18T11:56:09Z</dcterms:modified>
</cp:coreProperties>
</file>